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7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000FFA-EC7E-4CE2-9B55-9B1853A5347E}" v="1" dt="2021-03-26T23:21:43.39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48" d="100"/>
          <a:sy n="148" d="100"/>
        </p:scale>
        <p:origin x="437" y="-40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h Hill" userId="b774f213905f0ee8" providerId="LiveId" clId="{0B000FFA-EC7E-4CE2-9B55-9B1853A5347E}"/>
    <pc:docChg chg="modSld">
      <pc:chgData name="Sarah Hill" userId="b774f213905f0ee8" providerId="LiveId" clId="{0B000FFA-EC7E-4CE2-9B55-9B1853A5347E}" dt="2021-03-27T20:41:43.013" v="52" actId="20577"/>
      <pc:docMkLst>
        <pc:docMk/>
      </pc:docMkLst>
      <pc:sldChg chg="modSp mod">
        <pc:chgData name="Sarah Hill" userId="b774f213905f0ee8" providerId="LiveId" clId="{0B000FFA-EC7E-4CE2-9B55-9B1853A5347E}" dt="2021-03-26T19:52:16.358" v="8" actId="1035"/>
        <pc:sldMkLst>
          <pc:docMk/>
          <pc:sldMk cId="2152604478" sldId="257"/>
        </pc:sldMkLst>
        <pc:spChg chg="mod">
          <ac:chgData name="Sarah Hill" userId="b774f213905f0ee8" providerId="LiveId" clId="{0B000FFA-EC7E-4CE2-9B55-9B1853A5347E}" dt="2021-03-26T19:52:16.358" v="8" actId="1035"/>
          <ac:spMkLst>
            <pc:docMk/>
            <pc:sldMk cId="2152604478" sldId="257"/>
            <ac:spMk id="6" creationId="{576EC648-4F70-446D-8C0C-F94C74063A45}"/>
          </ac:spMkLst>
        </pc:spChg>
      </pc:sldChg>
      <pc:sldChg chg="addSp modSp mod">
        <pc:chgData name="Sarah Hill" userId="b774f213905f0ee8" providerId="LiveId" clId="{0B000FFA-EC7E-4CE2-9B55-9B1853A5347E}" dt="2021-03-27T20:41:43.013" v="52" actId="20577"/>
        <pc:sldMkLst>
          <pc:docMk/>
          <pc:sldMk cId="295490971" sldId="259"/>
        </pc:sldMkLst>
        <pc:spChg chg="add mod">
          <ac:chgData name="Sarah Hill" userId="b774f213905f0ee8" providerId="LiveId" clId="{0B000FFA-EC7E-4CE2-9B55-9B1853A5347E}" dt="2021-03-26T23:21:43.398" v="46"/>
          <ac:spMkLst>
            <pc:docMk/>
            <pc:sldMk cId="295490971" sldId="259"/>
            <ac:spMk id="3" creationId="{242C9D00-4B0E-41E2-88D4-44BEDE1D4320}"/>
          </ac:spMkLst>
        </pc:spChg>
        <pc:spChg chg="mod">
          <ac:chgData name="Sarah Hill" userId="b774f213905f0ee8" providerId="LiveId" clId="{0B000FFA-EC7E-4CE2-9B55-9B1853A5347E}" dt="2021-03-27T20:41:43.013" v="52" actId="20577"/>
          <ac:spMkLst>
            <pc:docMk/>
            <pc:sldMk cId="295490971" sldId="259"/>
            <ac:spMk id="4" creationId="{2F2F33FF-33A7-4DF2-B193-9D8F8F6390D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311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987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92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08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68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843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350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213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468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020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893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85499-F3A2-48B3-90C9-1DB533FCA489}" type="datetimeFigureOut">
              <a:rPr lang="en-US" smtClean="0"/>
              <a:t>3/2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2F8071-6ABC-4B86-94B4-21AD264B50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980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2F2F33FF-33A7-4DF2-B193-9D8F8F6390D0}"/>
              </a:ext>
            </a:extLst>
          </p:cNvPr>
          <p:cNvSpPr/>
          <p:nvPr/>
        </p:nvSpPr>
        <p:spPr>
          <a:xfrm>
            <a:off x="1605883" y="3181461"/>
            <a:ext cx="3429000" cy="5078313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Lane order for ARK1 </a:t>
            </a:r>
            <a:r>
              <a:rPr lang="en-US" dirty="0" err="1"/>
              <a:t>timecourse</a:t>
            </a:r>
            <a:r>
              <a:rPr lang="en-US" dirty="0"/>
              <a:t> in Figure S7C</a:t>
            </a:r>
          </a:p>
          <a:p>
            <a:endParaRPr lang="en-US" dirty="0"/>
          </a:p>
          <a:p>
            <a:r>
              <a:rPr lang="en-US" dirty="0"/>
              <a:t>14-empty</a:t>
            </a:r>
          </a:p>
          <a:p>
            <a:r>
              <a:rPr lang="en-US" dirty="0"/>
              <a:t>13-empty</a:t>
            </a:r>
          </a:p>
          <a:p>
            <a:r>
              <a:rPr lang="en-US" dirty="0"/>
              <a:t>12-ARK1 24hr 1775 + Alisertib</a:t>
            </a:r>
          </a:p>
          <a:p>
            <a:r>
              <a:rPr lang="en-US" dirty="0"/>
              <a:t>11 ARK1 24 </a:t>
            </a:r>
            <a:r>
              <a:rPr lang="en-US" dirty="0" err="1"/>
              <a:t>hr</a:t>
            </a:r>
            <a:r>
              <a:rPr lang="en-US" dirty="0"/>
              <a:t> Alisertib</a:t>
            </a:r>
          </a:p>
          <a:p>
            <a:r>
              <a:rPr lang="en-US" dirty="0"/>
              <a:t>10 ARK1 24 </a:t>
            </a:r>
            <a:r>
              <a:rPr lang="en-US" dirty="0" err="1"/>
              <a:t>hr</a:t>
            </a:r>
            <a:r>
              <a:rPr lang="en-US" dirty="0"/>
              <a:t> 1775</a:t>
            </a:r>
          </a:p>
          <a:p>
            <a:r>
              <a:rPr lang="en-US" dirty="0"/>
              <a:t>9 ARK1 24hr untreated</a:t>
            </a:r>
          </a:p>
          <a:p>
            <a:r>
              <a:rPr lang="en-US" dirty="0"/>
              <a:t>8 ARK1 8hr 1775+Alisertib</a:t>
            </a:r>
          </a:p>
          <a:p>
            <a:r>
              <a:rPr lang="en-US" dirty="0"/>
              <a:t>7 ARK1 8hr Alisertib</a:t>
            </a:r>
          </a:p>
          <a:p>
            <a:r>
              <a:rPr lang="en-US" dirty="0"/>
              <a:t>6 ARK1 8hr 1775</a:t>
            </a:r>
          </a:p>
          <a:p>
            <a:r>
              <a:rPr lang="en-US" dirty="0"/>
              <a:t>5 ARK1 8Hr untreated</a:t>
            </a:r>
          </a:p>
          <a:p>
            <a:r>
              <a:rPr lang="en-US" dirty="0"/>
              <a:t>4 ARK1 3 </a:t>
            </a:r>
            <a:r>
              <a:rPr lang="en-US" dirty="0" err="1"/>
              <a:t>hr</a:t>
            </a:r>
            <a:r>
              <a:rPr lang="en-US" dirty="0"/>
              <a:t> 1775 + Alisertib</a:t>
            </a:r>
          </a:p>
          <a:p>
            <a:r>
              <a:rPr lang="en-US" dirty="0"/>
              <a:t>3 ARK1 3hr Alisertib</a:t>
            </a:r>
          </a:p>
          <a:p>
            <a:r>
              <a:rPr lang="en-US" dirty="0"/>
              <a:t>2 ARK1 3Hr 1775</a:t>
            </a:r>
          </a:p>
          <a:p>
            <a:r>
              <a:rPr lang="en-US" dirty="0"/>
              <a:t>1 ARK1 3 </a:t>
            </a:r>
            <a:r>
              <a:rPr lang="en-US" dirty="0" err="1"/>
              <a:t>hr</a:t>
            </a:r>
            <a:r>
              <a:rPr lang="en-US" dirty="0"/>
              <a:t> untreated</a:t>
            </a:r>
          </a:p>
          <a:p>
            <a:r>
              <a:rPr lang="en-US" dirty="0"/>
              <a:t>Ladder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42C9D00-4B0E-41E2-88D4-44BEDE1D4320}"/>
              </a:ext>
            </a:extLst>
          </p:cNvPr>
          <p:cNvSpPr txBox="1"/>
          <p:nvPr/>
        </p:nvSpPr>
        <p:spPr>
          <a:xfrm>
            <a:off x="586154" y="339969"/>
            <a:ext cx="58615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r all blots specific to the figure, we have placed a box around the full western of interest and placed the lane numbers below. It.</a:t>
            </a:r>
          </a:p>
        </p:txBody>
      </p:sp>
    </p:spTree>
    <p:extLst>
      <p:ext uri="{BB962C8B-B14F-4D97-AF65-F5344CB8AC3E}">
        <p14:creationId xmlns:p14="http://schemas.microsoft.com/office/powerpoint/2010/main" val="2954909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Diagram&#10;&#10;Description automatically generated">
            <a:extLst>
              <a:ext uri="{FF2B5EF4-FFF2-40B4-BE49-F238E27FC236}">
                <a16:creationId xmlns:a16="http://schemas.microsoft.com/office/drawing/2014/main" id="{BF0637B9-FCE8-49A2-BBF8-8080B18E1EF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69961" y="952496"/>
            <a:ext cx="5452112" cy="6792038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576EC648-4F70-446D-8C0C-F94C74063A45}"/>
              </a:ext>
            </a:extLst>
          </p:cNvPr>
          <p:cNvSpPr/>
          <p:nvPr/>
        </p:nvSpPr>
        <p:spPr>
          <a:xfrm rot="479629">
            <a:off x="4369771" y="4543722"/>
            <a:ext cx="2081848" cy="21656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5392FD-07BA-41CD-B271-ECFEB4EB987E}"/>
              </a:ext>
            </a:extLst>
          </p:cNvPr>
          <p:cNvSpPr txBox="1"/>
          <p:nvPr/>
        </p:nvSpPr>
        <p:spPr>
          <a:xfrm rot="194525">
            <a:off x="4616197" y="4782739"/>
            <a:ext cx="19280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   2  3  4  5  6  7 8  9 10 11 1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515B110-7B99-4F93-AAD9-491B471C6D8F}"/>
              </a:ext>
            </a:extLst>
          </p:cNvPr>
          <p:cNvSpPr txBox="1"/>
          <p:nvPr/>
        </p:nvSpPr>
        <p:spPr>
          <a:xfrm>
            <a:off x="4610777" y="3585411"/>
            <a:ext cx="1753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leaved </a:t>
            </a:r>
            <a:r>
              <a:rPr lang="en-US" dirty="0" err="1"/>
              <a:t>parp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89FF98A-804E-4C30-B8C4-8EA8CE98D6A0}"/>
              </a:ext>
            </a:extLst>
          </p:cNvPr>
          <p:cNvSpPr txBox="1"/>
          <p:nvPr/>
        </p:nvSpPr>
        <p:spPr>
          <a:xfrm>
            <a:off x="2045368" y="529389"/>
            <a:ext cx="32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RK1 cleaved </a:t>
            </a:r>
            <a:r>
              <a:rPr lang="en-US" dirty="0" err="1"/>
              <a:t>parp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26044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Content Placeholder 7" descr="A picture containing engineering drawing&#10;&#10;Description automatically generated">
            <a:extLst>
              <a:ext uri="{FF2B5EF4-FFF2-40B4-BE49-F238E27FC236}">
                <a16:creationId xmlns:a16="http://schemas.microsoft.com/office/drawing/2014/main" id="{1EC722FE-80C5-4E0F-BFE5-1CEB7ED560F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96754" y="1538671"/>
            <a:ext cx="5494247" cy="6844528"/>
          </a:xfr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F3F81E4-2815-4C92-9B5F-1A31352FFC33}"/>
              </a:ext>
            </a:extLst>
          </p:cNvPr>
          <p:cNvSpPr/>
          <p:nvPr/>
        </p:nvSpPr>
        <p:spPr>
          <a:xfrm>
            <a:off x="4564479" y="4993106"/>
            <a:ext cx="1936249" cy="68580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6AEAEAF-7028-4CB4-AF2E-6DF86F53CC49}"/>
              </a:ext>
            </a:extLst>
          </p:cNvPr>
          <p:cNvSpPr txBox="1"/>
          <p:nvPr/>
        </p:nvSpPr>
        <p:spPr>
          <a:xfrm>
            <a:off x="4776535" y="5420230"/>
            <a:ext cx="19362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 2  3  4  5  6 7  8  9 10 11 1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B3201D0-0CD7-47BB-BC76-7E2A04D02C61}"/>
              </a:ext>
            </a:extLst>
          </p:cNvPr>
          <p:cNvSpPr txBox="1"/>
          <p:nvPr/>
        </p:nvSpPr>
        <p:spPr>
          <a:xfrm>
            <a:off x="2045368" y="529389"/>
            <a:ext cx="32605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RK1 vincul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E543491-FFC6-44EE-9138-8F646800342C}"/>
              </a:ext>
            </a:extLst>
          </p:cNvPr>
          <p:cNvSpPr txBox="1"/>
          <p:nvPr/>
        </p:nvSpPr>
        <p:spPr>
          <a:xfrm>
            <a:off x="3732023" y="4831391"/>
            <a:ext cx="1015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inculin</a:t>
            </a:r>
          </a:p>
        </p:txBody>
      </p:sp>
    </p:spTree>
    <p:extLst>
      <p:ext uri="{BB962C8B-B14F-4D97-AF65-F5344CB8AC3E}">
        <p14:creationId xmlns:p14="http://schemas.microsoft.com/office/powerpoint/2010/main" val="15996144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8</Words>
  <Application>Microsoft Office PowerPoint</Application>
  <PresentationFormat>Letter Paper (8.5x11 in)</PresentationFormat>
  <Paragraphs>2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nch, Katherine N.</dc:creator>
  <cp:lastModifiedBy>Sarah Hill</cp:lastModifiedBy>
  <cp:revision>6</cp:revision>
  <dcterms:created xsi:type="dcterms:W3CDTF">2021-03-25T15:10:13Z</dcterms:created>
  <dcterms:modified xsi:type="dcterms:W3CDTF">2021-03-27T20:41:44Z</dcterms:modified>
</cp:coreProperties>
</file>